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6"/>
  </p:notesMasterIdLst>
  <p:sldIdLst>
    <p:sldId id="425" r:id="rId2"/>
    <p:sldId id="275" r:id="rId3"/>
    <p:sldId id="427" r:id="rId4"/>
    <p:sldId id="268" r:id="rId5"/>
    <p:sldId id="270" r:id="rId6"/>
    <p:sldId id="421" r:id="rId7"/>
    <p:sldId id="423" r:id="rId8"/>
    <p:sldId id="424" r:id="rId9"/>
    <p:sldId id="258" r:id="rId10"/>
    <p:sldId id="422" r:id="rId11"/>
    <p:sldId id="272" r:id="rId12"/>
    <p:sldId id="413" r:id="rId13"/>
    <p:sldId id="417" r:id="rId14"/>
    <p:sldId id="418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7" orient="horz" pos="466" userDrawn="1">
          <p15:clr>
            <a:srgbClr val="A4A3A4"/>
          </p15:clr>
        </p15:guide>
        <p15:guide id="28" pos="3430" userDrawn="1">
          <p15:clr>
            <a:srgbClr val="A4A3A4"/>
          </p15:clr>
        </p15:guide>
        <p15:guide id="29" pos="550" userDrawn="1">
          <p15:clr>
            <a:srgbClr val="A4A3A4"/>
          </p15:clr>
        </p15:guide>
        <p15:guide id="30" orient="horz" pos="169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 snapToGrid="0" snapToObjects="1" showGuides="1">
      <p:cViewPr varScale="1">
        <p:scale>
          <a:sx n="78" d="100"/>
          <a:sy n="78" d="100"/>
        </p:scale>
        <p:origin x="3064" y="176"/>
      </p:cViewPr>
      <p:guideLst>
        <p:guide orient="horz" pos="466"/>
        <p:guide pos="3430"/>
        <p:guide pos="550"/>
        <p:guide orient="horz" pos="16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3BAA12-FC18-0E4E-AF5A-CB676B143D86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5778B7-7BE6-064D-9D83-2428128EBA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752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5220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1807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2683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054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255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867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171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872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2717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361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693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1AB4B-DCA8-4F4E-981A-FEFEDA189B48}" type="datetimeFigureOut">
              <a:rPr lang="en-GB" smtClean="0"/>
              <a:t>08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5581B-FE56-5545-9D35-69E09A45BE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6778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35.png"/><Relationship Id="rId18" Type="http://schemas.openxmlformats.org/officeDocument/2006/relationships/image" Target="../media/image38.emf"/><Relationship Id="rId3" Type="http://schemas.openxmlformats.org/officeDocument/2006/relationships/image" Target="../media/image29.emf"/><Relationship Id="rId7" Type="http://schemas.openxmlformats.org/officeDocument/2006/relationships/image" Target="../media/image32.png"/><Relationship Id="rId12" Type="http://schemas.microsoft.com/office/2007/relationships/hdphoto" Target="../media/hdphoto4.wdp"/><Relationship Id="rId17" Type="http://schemas.openxmlformats.org/officeDocument/2006/relationships/image" Target="../media/image37.emf"/><Relationship Id="rId2" Type="http://schemas.openxmlformats.org/officeDocument/2006/relationships/image" Target="../media/image28.emf"/><Relationship Id="rId16" Type="http://schemas.microsoft.com/office/2007/relationships/hdphoto" Target="../media/hdphoto6.wdp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34.png"/><Relationship Id="rId5" Type="http://schemas.openxmlformats.org/officeDocument/2006/relationships/image" Target="../media/image31.png"/><Relationship Id="rId15" Type="http://schemas.openxmlformats.org/officeDocument/2006/relationships/image" Target="../media/image36.png"/><Relationship Id="rId10" Type="http://schemas.microsoft.com/office/2007/relationships/hdphoto" Target="../media/hdphoto3.wdp"/><Relationship Id="rId4" Type="http://schemas.openxmlformats.org/officeDocument/2006/relationships/image" Target="../media/image30.emf"/><Relationship Id="rId9" Type="http://schemas.openxmlformats.org/officeDocument/2006/relationships/image" Target="../media/image33.png"/><Relationship Id="rId14" Type="http://schemas.microsoft.com/office/2007/relationships/hdphoto" Target="../media/hdphoto5.wdp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40.emf"/><Relationship Id="rId7" Type="http://schemas.microsoft.com/office/2007/relationships/hdphoto" Target="../media/hdphoto8.wdp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pn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44.png"/><Relationship Id="rId4" Type="http://schemas.openxmlformats.org/officeDocument/2006/relationships/image" Target="../media/image41.png"/><Relationship Id="rId9" Type="http://schemas.microsoft.com/office/2007/relationships/hdphoto" Target="../media/hdphoto9.wdp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emf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9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D753918-51F3-4049-A23D-FE59D2D238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584" y="933697"/>
            <a:ext cx="5874832" cy="58915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1948A46-D765-BE4F-9BAD-55B6CDDD751A}"/>
              </a:ext>
            </a:extLst>
          </p:cNvPr>
          <p:cNvSpPr txBox="1"/>
          <p:nvPr/>
        </p:nvSpPr>
        <p:spPr>
          <a:xfrm>
            <a:off x="4392386" y="9470571"/>
            <a:ext cx="2437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Table S1</a:t>
            </a:r>
          </a:p>
        </p:txBody>
      </p:sp>
    </p:spTree>
    <p:extLst>
      <p:ext uri="{BB962C8B-B14F-4D97-AF65-F5344CB8AC3E}">
        <p14:creationId xmlns:p14="http://schemas.microsoft.com/office/powerpoint/2010/main" val="23124607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6847A96-701D-0F4C-8298-EE0F8E366B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823" y="373016"/>
            <a:ext cx="6225857" cy="90135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9868C41-B8CD-E64F-ACB9-8EA965A3A9AC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86BB06-D305-0441-89FD-DEE87AF8A117}"/>
              </a:ext>
            </a:extLst>
          </p:cNvPr>
          <p:cNvSpPr txBox="1"/>
          <p:nvPr/>
        </p:nvSpPr>
        <p:spPr>
          <a:xfrm>
            <a:off x="119126" y="9060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l)</a:t>
            </a:r>
          </a:p>
        </p:txBody>
      </p:sp>
    </p:spTree>
    <p:extLst>
      <p:ext uri="{BB962C8B-B14F-4D97-AF65-F5344CB8AC3E}">
        <p14:creationId xmlns:p14="http://schemas.microsoft.com/office/powerpoint/2010/main" val="28540813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A707F95-B0B6-2341-8C2B-BC96F53EE91D}"/>
              </a:ext>
            </a:extLst>
          </p:cNvPr>
          <p:cNvSpPr txBox="1"/>
          <p:nvPr/>
        </p:nvSpPr>
        <p:spPr>
          <a:xfrm>
            <a:off x="4392386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7EA97E-1317-E840-95A3-5356AAD69E5B}"/>
              </a:ext>
            </a:extLst>
          </p:cNvPr>
          <p:cNvSpPr txBox="1"/>
          <p:nvPr/>
        </p:nvSpPr>
        <p:spPr>
          <a:xfrm>
            <a:off x="73220" y="104671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73A8FE-DBDE-8842-B7C0-53675BAE995E}"/>
              </a:ext>
            </a:extLst>
          </p:cNvPr>
          <p:cNvSpPr txBox="1"/>
          <p:nvPr/>
        </p:nvSpPr>
        <p:spPr>
          <a:xfrm>
            <a:off x="73220" y="3530600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616D6FF-86DF-5646-BB0E-21DD2B02A8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156" y="461434"/>
            <a:ext cx="1754396" cy="253647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2EC4772-A2CE-2E4C-B8DD-1E253A9028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79" y="3543300"/>
            <a:ext cx="6793568" cy="2808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0551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TextBox 138">
            <a:extLst>
              <a:ext uri="{FF2B5EF4-FFF2-40B4-BE49-F238E27FC236}">
                <a16:creationId xmlns:a16="http://schemas.microsoft.com/office/drawing/2014/main" id="{5D54B9E1-3A61-8B40-88D8-6929F2243CA8}"/>
              </a:ext>
            </a:extLst>
          </p:cNvPr>
          <p:cNvSpPr txBox="1"/>
          <p:nvPr/>
        </p:nvSpPr>
        <p:spPr>
          <a:xfrm>
            <a:off x="4392386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4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389098A8-5C4F-C94C-B9BB-4340341BCEDE}"/>
              </a:ext>
            </a:extLst>
          </p:cNvPr>
          <p:cNvSpPr txBox="1"/>
          <p:nvPr/>
        </p:nvSpPr>
        <p:spPr>
          <a:xfrm>
            <a:off x="176893" y="247077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0814A632-93B6-EB4B-A2A9-BF636864B16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82957" y="247077"/>
            <a:ext cx="1526304" cy="1908000"/>
          </a:xfrm>
          <a:prstGeom prst="rect">
            <a:avLst/>
          </a:prstGeom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id="{F2EC0E72-5281-D241-B107-AA3E39D5C57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812518" y="247077"/>
            <a:ext cx="1526400" cy="1908000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D3666DBB-FB8C-084F-89AD-AE0F1A92E160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47690" y="247077"/>
            <a:ext cx="1526400" cy="190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8E5CD3D-0605-7642-9630-4EF4B056D352}"/>
              </a:ext>
            </a:extLst>
          </p:cNvPr>
          <p:cNvSpPr txBox="1"/>
          <p:nvPr/>
        </p:nvSpPr>
        <p:spPr>
          <a:xfrm>
            <a:off x="176893" y="2802186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)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FE691D1-0F28-D641-99F8-2DD860EA8253}"/>
              </a:ext>
            </a:extLst>
          </p:cNvPr>
          <p:cNvGrpSpPr/>
          <p:nvPr/>
        </p:nvGrpSpPr>
        <p:grpSpPr>
          <a:xfrm>
            <a:off x="238553" y="2716605"/>
            <a:ext cx="3031040" cy="4472790"/>
            <a:chOff x="290716" y="39310"/>
            <a:chExt cx="3031040" cy="4472790"/>
          </a:xfrm>
        </p:grpSpPr>
        <p:pic>
          <p:nvPicPr>
            <p:cNvPr id="9" name="Picture 8" descr="A close-up of a test results&#10;&#10;AI-generated content may be incorrect.">
              <a:extLst>
                <a:ext uri="{FF2B5EF4-FFF2-40B4-BE49-F238E27FC236}">
                  <a16:creationId xmlns:a16="http://schemas.microsoft.com/office/drawing/2014/main" id="{FFEF231E-C41D-094A-88E6-AE1703454C8D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30688" y="793589"/>
              <a:ext cx="2257200" cy="356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72AA7E9-4229-1247-A379-384D9B741FF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30688" y="1186270"/>
              <a:ext cx="2258660" cy="356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 descr="A close-up of a test paper&#10;&#10;AI-generated content may be incorrect.">
              <a:extLst>
                <a:ext uri="{FF2B5EF4-FFF2-40B4-BE49-F238E27FC236}">
                  <a16:creationId xmlns:a16="http://schemas.microsoft.com/office/drawing/2014/main" id="{8E7095B8-EF59-844E-AB5D-C23A5C75A6B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30688" y="1581919"/>
              <a:ext cx="2258659" cy="356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1A87E1-64B7-1E49-96DE-9679F0EEAA7F}"/>
                </a:ext>
              </a:extLst>
            </p:cNvPr>
            <p:cNvSpPr txBox="1"/>
            <p:nvPr/>
          </p:nvSpPr>
          <p:spPr>
            <a:xfrm>
              <a:off x="423188" y="833291"/>
              <a:ext cx="6116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BACH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E528830-4638-E146-8B66-66C12CD35916}"/>
                </a:ext>
              </a:extLst>
            </p:cNvPr>
            <p:cNvSpPr txBox="1"/>
            <p:nvPr/>
          </p:nvSpPr>
          <p:spPr>
            <a:xfrm>
              <a:off x="290716" y="1621620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TUBUL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1131150-97C8-A84A-9788-907421BB1ADD}"/>
                </a:ext>
              </a:extLst>
            </p:cNvPr>
            <p:cNvSpPr txBox="1"/>
            <p:nvPr/>
          </p:nvSpPr>
          <p:spPr>
            <a:xfrm>
              <a:off x="426971" y="1225971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AM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46AE6B8-5324-8946-8E3A-F004ADFDD309}"/>
                </a:ext>
              </a:extLst>
            </p:cNvPr>
            <p:cNvSpPr txBox="1"/>
            <p:nvPr/>
          </p:nvSpPr>
          <p:spPr>
            <a:xfrm rot="16200000">
              <a:off x="931440" y="428211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A8927DA-4DEC-CF4A-A9F8-77B7CA0F43AB}"/>
                </a:ext>
              </a:extLst>
            </p:cNvPr>
            <p:cNvSpPr txBox="1"/>
            <p:nvPr/>
          </p:nvSpPr>
          <p:spPr>
            <a:xfrm rot="16200000">
              <a:off x="1212791" y="434463"/>
              <a:ext cx="5437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lanto</a:t>
              </a:r>
              <a:endParaRPr lang="en-GB" sz="105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7BF41BA-1790-3F48-9250-72D66152FE87}"/>
                </a:ext>
              </a:extLst>
            </p:cNvPr>
            <p:cNvSpPr txBox="1"/>
            <p:nvPr/>
          </p:nvSpPr>
          <p:spPr>
            <a:xfrm rot="16200000">
              <a:off x="1530275" y="467325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CH5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71B2E40-BE24-D143-9AD8-4362E4C69EDF}"/>
                </a:ext>
              </a:extLst>
            </p:cNvPr>
            <p:cNvSpPr txBox="1"/>
            <p:nvPr/>
          </p:nvSpPr>
          <p:spPr>
            <a:xfrm rot="16200000">
              <a:off x="1777589" y="448890"/>
              <a:ext cx="5148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uran</a:t>
              </a:r>
              <a:endParaRPr lang="en-GB" sz="105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92C27DE-D510-1846-A1DD-BC8C27979950}"/>
                </a:ext>
              </a:extLst>
            </p:cNvPr>
            <p:cNvSpPr txBox="1"/>
            <p:nvPr/>
          </p:nvSpPr>
          <p:spPr>
            <a:xfrm>
              <a:off x="2552899" y="39310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KPT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7AFEFAD-5D13-5445-99E0-33A2DE1D390E}"/>
                </a:ext>
              </a:extLst>
            </p:cNvPr>
            <p:cNvCxnSpPr>
              <a:cxnSpLocks/>
            </p:cNvCxnSpPr>
            <p:nvPr/>
          </p:nvCxnSpPr>
          <p:spPr>
            <a:xfrm>
              <a:off x="2251774" y="288169"/>
              <a:ext cx="9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D2F365F-A3B6-174F-A302-C3D7170C0F7A}"/>
                </a:ext>
              </a:extLst>
            </p:cNvPr>
            <p:cNvSpPr txBox="1"/>
            <p:nvPr/>
          </p:nvSpPr>
          <p:spPr>
            <a:xfrm rot="16200000">
              <a:off x="2042698" y="428212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5968FA0-5301-3949-BD5C-EB0F269C86E0}"/>
                </a:ext>
              </a:extLst>
            </p:cNvPr>
            <p:cNvSpPr txBox="1"/>
            <p:nvPr/>
          </p:nvSpPr>
          <p:spPr>
            <a:xfrm rot="16200000">
              <a:off x="2317225" y="434463"/>
              <a:ext cx="5437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lanto</a:t>
              </a:r>
              <a:endParaRPr lang="en-GB" sz="10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860529F-CD89-954B-8505-68DDE5541FEB}"/>
                </a:ext>
              </a:extLst>
            </p:cNvPr>
            <p:cNvSpPr txBox="1"/>
            <p:nvPr/>
          </p:nvSpPr>
          <p:spPr>
            <a:xfrm rot="16200000">
              <a:off x="2642680" y="467325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CH5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99CF9F8-2FD6-DE44-8A07-5E7209FCD5BC}"/>
                </a:ext>
              </a:extLst>
            </p:cNvPr>
            <p:cNvSpPr txBox="1"/>
            <p:nvPr/>
          </p:nvSpPr>
          <p:spPr>
            <a:xfrm rot="16200000">
              <a:off x="2882023" y="448890"/>
              <a:ext cx="5148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uran</a:t>
              </a:r>
              <a:endParaRPr lang="en-GB" sz="105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2BAC26F-A250-844E-9AEC-13000AAF4D38}"/>
                </a:ext>
              </a:extLst>
            </p:cNvPr>
            <p:cNvSpPr txBox="1"/>
            <p:nvPr/>
          </p:nvSpPr>
          <p:spPr>
            <a:xfrm>
              <a:off x="462985" y="3138094"/>
              <a:ext cx="6116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BACH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DED8C2B-FA16-B34C-A910-6793517E9D2B}"/>
                </a:ext>
              </a:extLst>
            </p:cNvPr>
            <p:cNvSpPr txBox="1"/>
            <p:nvPr/>
          </p:nvSpPr>
          <p:spPr>
            <a:xfrm>
              <a:off x="330513" y="3926423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TUBULIN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1EDEEE3-EC78-A74D-B8FA-9BCAF81CC55A}"/>
                </a:ext>
              </a:extLst>
            </p:cNvPr>
            <p:cNvSpPr txBox="1"/>
            <p:nvPr/>
          </p:nvSpPr>
          <p:spPr>
            <a:xfrm>
              <a:off x="466768" y="3530774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AMI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8A5715D-B3AE-664F-BA27-91EC98579543}"/>
                </a:ext>
              </a:extLst>
            </p:cNvPr>
            <p:cNvSpPr txBox="1"/>
            <p:nvPr/>
          </p:nvSpPr>
          <p:spPr>
            <a:xfrm rot="16200000">
              <a:off x="931440" y="2733014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3AF69ED-45C3-DD49-A7AB-B45B31302299}"/>
                </a:ext>
              </a:extLst>
            </p:cNvPr>
            <p:cNvSpPr txBox="1"/>
            <p:nvPr/>
          </p:nvSpPr>
          <p:spPr>
            <a:xfrm rot="16200000">
              <a:off x="1212791" y="2739266"/>
              <a:ext cx="5437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lanto</a:t>
              </a:r>
              <a:endParaRPr lang="en-GB" sz="105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A02002A-AA1D-6E4B-BF89-CFE37614448B}"/>
                </a:ext>
              </a:extLst>
            </p:cNvPr>
            <p:cNvSpPr txBox="1"/>
            <p:nvPr/>
          </p:nvSpPr>
          <p:spPr>
            <a:xfrm rot="16200000">
              <a:off x="1530275" y="2772128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CH5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FFBA30B-BDE1-454F-860D-E03B3F3591A4}"/>
                </a:ext>
              </a:extLst>
            </p:cNvPr>
            <p:cNvSpPr txBox="1"/>
            <p:nvPr/>
          </p:nvSpPr>
          <p:spPr>
            <a:xfrm rot="16200000">
              <a:off x="1777589" y="2753693"/>
              <a:ext cx="5148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uran</a:t>
              </a:r>
              <a:endParaRPr lang="en-GB" sz="105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9414D2A-9623-D349-A365-51959B2FBC40}"/>
                </a:ext>
              </a:extLst>
            </p:cNvPr>
            <p:cNvSpPr txBox="1"/>
            <p:nvPr/>
          </p:nvSpPr>
          <p:spPr>
            <a:xfrm>
              <a:off x="2592696" y="2328615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KPT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0D602150-A3D8-9B43-954C-C4DCA3A2259E}"/>
                </a:ext>
              </a:extLst>
            </p:cNvPr>
            <p:cNvCxnSpPr>
              <a:cxnSpLocks/>
            </p:cNvCxnSpPr>
            <p:nvPr/>
          </p:nvCxnSpPr>
          <p:spPr>
            <a:xfrm>
              <a:off x="2291571" y="2577474"/>
              <a:ext cx="9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53D83DF-A45C-C542-BEA6-32C7F2070C7C}"/>
                </a:ext>
              </a:extLst>
            </p:cNvPr>
            <p:cNvSpPr txBox="1"/>
            <p:nvPr/>
          </p:nvSpPr>
          <p:spPr>
            <a:xfrm rot="16200000">
              <a:off x="2042698" y="2733015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FBCFFBD-FB2D-014A-B09B-42B9517A9A58}"/>
                </a:ext>
              </a:extLst>
            </p:cNvPr>
            <p:cNvSpPr txBox="1"/>
            <p:nvPr/>
          </p:nvSpPr>
          <p:spPr>
            <a:xfrm rot="16200000">
              <a:off x="2317225" y="2739266"/>
              <a:ext cx="5437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lanto</a:t>
              </a:r>
              <a:endParaRPr lang="en-GB" sz="105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0D9D8BF-5432-4B43-80B3-F1CF2E490D52}"/>
                </a:ext>
              </a:extLst>
            </p:cNvPr>
            <p:cNvSpPr txBox="1"/>
            <p:nvPr/>
          </p:nvSpPr>
          <p:spPr>
            <a:xfrm rot="16200000">
              <a:off x="2642680" y="2772128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CH5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AE74E97-3D22-9948-A527-14EEB6CCD96E}"/>
                </a:ext>
              </a:extLst>
            </p:cNvPr>
            <p:cNvSpPr txBox="1"/>
            <p:nvPr/>
          </p:nvSpPr>
          <p:spPr>
            <a:xfrm rot="16200000">
              <a:off x="2895671" y="2753693"/>
              <a:ext cx="5148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Auran</a:t>
              </a:r>
              <a:endParaRPr lang="en-GB" sz="105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C1F48E3-21D8-3545-BEC9-66AD437ACF46}"/>
                </a:ext>
              </a:extLst>
            </p:cNvPr>
            <p:cNvSpPr txBox="1"/>
            <p:nvPr/>
          </p:nvSpPr>
          <p:spPr>
            <a:xfrm>
              <a:off x="1799750" y="1916887"/>
              <a:ext cx="777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Nucleu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4548105-7761-E24D-8A28-7DB8DD40E48D}"/>
                </a:ext>
              </a:extLst>
            </p:cNvPr>
            <p:cNvSpPr txBox="1"/>
            <p:nvPr/>
          </p:nvSpPr>
          <p:spPr>
            <a:xfrm>
              <a:off x="1715080" y="4204323"/>
              <a:ext cx="9693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Cytoplasm</a:t>
              </a:r>
            </a:p>
          </p:txBody>
        </p:sp>
        <p:pic>
          <p:nvPicPr>
            <p:cNvPr id="40" name="Picture 39" descr="A list of food items&#10;&#10;AI-generated content may be incorrect.">
              <a:extLst>
                <a:ext uri="{FF2B5EF4-FFF2-40B4-BE49-F238E27FC236}">
                  <a16:creationId xmlns:a16="http://schemas.microsoft.com/office/drawing/2014/main" id="{02F4223D-B650-934B-8BB3-313273B57555}"/>
                </a:ext>
              </a:extLst>
            </p:cNvPr>
            <p:cNvPicPr>
              <a:picLocks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2014956" y="2942992"/>
              <a:ext cx="356400" cy="22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Picture 40" descr="A close-up of a test results&#10;&#10;AI-generated content may be incorrect.">
              <a:extLst>
                <a:ext uri="{FF2B5EF4-FFF2-40B4-BE49-F238E27FC236}">
                  <a16:creationId xmlns:a16="http://schemas.microsoft.com/office/drawing/2014/main" id="{5FCC3613-7901-8B44-B890-3663C0CE60B3}"/>
                </a:ext>
              </a:extLst>
            </p:cNvPr>
            <p:cNvPicPr>
              <a:picLocks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2014956" y="2154663"/>
              <a:ext cx="356400" cy="22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Picture 41" descr="A black line on a white background&#10;&#10;AI-generated content may be incorrect.">
              <a:extLst>
                <a:ext uri="{FF2B5EF4-FFF2-40B4-BE49-F238E27FC236}">
                  <a16:creationId xmlns:a16="http://schemas.microsoft.com/office/drawing/2014/main" id="{60CD016B-37D9-8545-901E-5FDBB34D145A}"/>
                </a:ext>
              </a:extLst>
            </p:cNvPr>
            <p:cNvPicPr>
              <a:picLocks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2014956" y="2547343"/>
              <a:ext cx="356400" cy="22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43" name="Picture 42">
            <a:extLst>
              <a:ext uri="{FF2B5EF4-FFF2-40B4-BE49-F238E27FC236}">
                <a16:creationId xmlns:a16="http://schemas.microsoft.com/office/drawing/2014/main" id="{7A49F749-D45A-7B41-BB4C-51CBFFA04E44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3663389" y="2831796"/>
            <a:ext cx="2440800" cy="22788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7078944A-37C0-EB49-87D8-8F060FD30704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663389" y="5318837"/>
            <a:ext cx="2440800" cy="227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984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A48D87-BF2F-964F-9335-665FBF269CEA}"/>
              </a:ext>
            </a:extLst>
          </p:cNvPr>
          <p:cNvSpPr txBox="1"/>
          <p:nvPr/>
        </p:nvSpPr>
        <p:spPr>
          <a:xfrm>
            <a:off x="4392386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6D810B9-FB12-8C41-B33D-E3FEE262B891}"/>
              </a:ext>
            </a:extLst>
          </p:cNvPr>
          <p:cNvSpPr txBox="1"/>
          <p:nvPr/>
        </p:nvSpPr>
        <p:spPr>
          <a:xfrm>
            <a:off x="229056" y="124891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E966631-A3A5-8C4B-9C27-0C037624C8A1}"/>
              </a:ext>
            </a:extLst>
          </p:cNvPr>
          <p:cNvSpPr txBox="1"/>
          <p:nvPr/>
        </p:nvSpPr>
        <p:spPr>
          <a:xfrm>
            <a:off x="229056" y="3230051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BEDB764-1A18-7E47-9934-93C62485E0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9556" y="432668"/>
            <a:ext cx="2473775" cy="2253884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887E55BF-EE89-FE43-9B11-17ADB3AC4B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5498" y="3414337"/>
            <a:ext cx="2473775" cy="2272208"/>
          </a:xfrm>
          <a:prstGeom prst="rect">
            <a:avLst/>
          </a:prstGeom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9DFD0C64-4BD1-E047-A771-9C596E4E8397}"/>
              </a:ext>
            </a:extLst>
          </p:cNvPr>
          <p:cNvGrpSpPr/>
          <p:nvPr/>
        </p:nvGrpSpPr>
        <p:grpSpPr>
          <a:xfrm>
            <a:off x="163543" y="3406953"/>
            <a:ext cx="2519776" cy="2629518"/>
            <a:chOff x="264486" y="7211512"/>
            <a:chExt cx="2519776" cy="2629518"/>
          </a:xfrm>
        </p:grpSpPr>
        <p:pic>
          <p:nvPicPr>
            <p:cNvPr id="65" name="Picture 64" descr="A close-up of a microscope slide&#10;&#10;Description automatically generated">
              <a:extLst>
                <a:ext uri="{FF2B5EF4-FFF2-40B4-BE49-F238E27FC236}">
                  <a16:creationId xmlns:a16="http://schemas.microsoft.com/office/drawing/2014/main" id="{978993F7-AB98-4D40-B173-91301747A4EF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1698862" y="7253474"/>
              <a:ext cx="360000" cy="1810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Picture 65" descr="A blue sky with black text&#10;&#10;Description automatically generated">
              <a:extLst>
                <a:ext uri="{FF2B5EF4-FFF2-40B4-BE49-F238E27FC236}">
                  <a16:creationId xmlns:a16="http://schemas.microsoft.com/office/drawing/2014/main" id="{5F5B2079-F420-E84F-8007-CC24B001A8E4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1698862" y="8038979"/>
              <a:ext cx="360000" cy="1810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F905E8E-19E2-F347-BB4B-E0302013BEA5}"/>
                </a:ext>
              </a:extLst>
            </p:cNvPr>
            <p:cNvSpPr txBox="1"/>
            <p:nvPr/>
          </p:nvSpPr>
          <p:spPr>
            <a:xfrm>
              <a:off x="396958" y="8019369"/>
              <a:ext cx="6116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BACH1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4A4B131-101A-F049-869B-2F9B1F67D4F4}"/>
                </a:ext>
              </a:extLst>
            </p:cNvPr>
            <p:cNvSpPr txBox="1"/>
            <p:nvPr/>
          </p:nvSpPr>
          <p:spPr>
            <a:xfrm>
              <a:off x="400741" y="8793163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AMIN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6D4458A-571F-3B43-81A9-FB6F012F12E8}"/>
                </a:ext>
              </a:extLst>
            </p:cNvPr>
            <p:cNvSpPr txBox="1"/>
            <p:nvPr/>
          </p:nvSpPr>
          <p:spPr>
            <a:xfrm>
              <a:off x="517825" y="8406986"/>
              <a:ext cx="4907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LC3B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E107D20-53C9-6E42-9D58-B2C4A3AF46A8}"/>
                </a:ext>
              </a:extLst>
            </p:cNvPr>
            <p:cNvSpPr txBox="1"/>
            <p:nvPr/>
          </p:nvSpPr>
          <p:spPr>
            <a:xfrm rot="16200000">
              <a:off x="877983" y="7622705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5328F4C-EDE0-6B4B-AC90-2C2EFB8C7D17}"/>
                </a:ext>
              </a:extLst>
            </p:cNvPr>
            <p:cNvSpPr txBox="1"/>
            <p:nvPr/>
          </p:nvSpPr>
          <p:spPr>
            <a:xfrm rot="16200000">
              <a:off x="1153149" y="760026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Xantho</a:t>
              </a:r>
              <a:endParaRPr lang="en-GB" sz="105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E5C43E60-92D0-9A4B-8A9B-CCE6C8D62714}"/>
                </a:ext>
              </a:extLst>
            </p:cNvPr>
            <p:cNvSpPr txBox="1"/>
            <p:nvPr/>
          </p:nvSpPr>
          <p:spPr>
            <a:xfrm rot="16200000">
              <a:off x="1473199" y="7622705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ED5D4F34-69FD-6940-8805-85984E7F608A}"/>
                </a:ext>
              </a:extLst>
            </p:cNvPr>
            <p:cNvSpPr txBox="1"/>
            <p:nvPr/>
          </p:nvSpPr>
          <p:spPr>
            <a:xfrm rot="16200000">
              <a:off x="1748365" y="760026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Xantho</a:t>
              </a:r>
              <a:endParaRPr lang="en-GB" sz="1050" dirty="0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910001A-17AE-D749-874E-E3C3CF627EBA}"/>
                </a:ext>
              </a:extLst>
            </p:cNvPr>
            <p:cNvSpPr txBox="1"/>
            <p:nvPr/>
          </p:nvSpPr>
          <p:spPr>
            <a:xfrm rot="16200000">
              <a:off x="2038012" y="7622705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DMSO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187A24B8-19CD-6542-B012-ED23E70F81F9}"/>
                </a:ext>
              </a:extLst>
            </p:cNvPr>
            <p:cNvSpPr txBox="1"/>
            <p:nvPr/>
          </p:nvSpPr>
          <p:spPr>
            <a:xfrm rot="16200000">
              <a:off x="2313178" y="760026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/>
                <a:t>Xantho</a:t>
              </a:r>
              <a:endParaRPr lang="en-GB" sz="1050" dirty="0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E35F5984-7ED8-1744-884F-DC35F58B914C}"/>
                </a:ext>
              </a:extLst>
            </p:cNvPr>
            <p:cNvSpPr txBox="1"/>
            <p:nvPr/>
          </p:nvSpPr>
          <p:spPr>
            <a:xfrm>
              <a:off x="1701128" y="7215893"/>
              <a:ext cx="3481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CQ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E321833-380C-4348-85FC-FD542811C536}"/>
                </a:ext>
              </a:extLst>
            </p:cNvPr>
            <p:cNvSpPr txBox="1"/>
            <p:nvPr/>
          </p:nvSpPr>
          <p:spPr>
            <a:xfrm>
              <a:off x="2204759" y="7211512"/>
              <a:ext cx="54694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/>
                <a:t>BAF1A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9FFC93AA-9744-9146-AE1C-0A9595A7ED3A}"/>
                </a:ext>
              </a:extLst>
            </p:cNvPr>
            <p:cNvCxnSpPr>
              <a:cxnSpLocks/>
            </p:cNvCxnSpPr>
            <p:nvPr/>
          </p:nvCxnSpPr>
          <p:spPr>
            <a:xfrm>
              <a:off x="1648739" y="7460371"/>
              <a:ext cx="46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245A561D-44FF-5343-B061-B5C8ACC9B999}"/>
                </a:ext>
              </a:extLst>
            </p:cNvPr>
            <p:cNvCxnSpPr>
              <a:cxnSpLocks/>
            </p:cNvCxnSpPr>
            <p:nvPr/>
          </p:nvCxnSpPr>
          <p:spPr>
            <a:xfrm>
              <a:off x="2230211" y="7460371"/>
              <a:ext cx="46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8" name="Picture 97" descr="A close-up of a microscope slide&#10;&#10;Description automatically generated">
              <a:extLst>
                <a:ext uri="{FF2B5EF4-FFF2-40B4-BE49-F238E27FC236}">
                  <a16:creationId xmlns:a16="http://schemas.microsoft.com/office/drawing/2014/main" id="{F6BCDD65-E411-7249-B470-E76B4CAE62D7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1700662" y="7646226"/>
              <a:ext cx="356400" cy="1810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9" name="Picture 98" descr="A close-up of several black worms&#10;&#10;Description automatically generated">
              <a:extLst>
                <a:ext uri="{FF2B5EF4-FFF2-40B4-BE49-F238E27FC236}">
                  <a16:creationId xmlns:a16="http://schemas.microsoft.com/office/drawing/2014/main" id="{C898F406-C103-5F4A-AEDB-C7AC7CFCE59A}"/>
                </a:ext>
              </a:extLst>
            </p:cNvPr>
            <p:cNvPicPr>
              <a:picLocks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1700662" y="8431879"/>
              <a:ext cx="356400" cy="1810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09EA6BDA-2F76-D84D-82EA-D7D7526B1A81}"/>
                </a:ext>
              </a:extLst>
            </p:cNvPr>
            <p:cNvSpPr txBox="1"/>
            <p:nvPr/>
          </p:nvSpPr>
          <p:spPr>
            <a:xfrm>
              <a:off x="264486" y="9198779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TUBULIN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2BA8447-5348-104A-ABFA-819994692092}"/>
                </a:ext>
              </a:extLst>
            </p:cNvPr>
            <p:cNvSpPr txBox="1"/>
            <p:nvPr/>
          </p:nvSpPr>
          <p:spPr>
            <a:xfrm>
              <a:off x="1463903" y="9533253"/>
              <a:ext cx="777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Nucleu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36342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90DB16CA-4A92-D14B-8DB6-0535DA02A2D2}"/>
              </a:ext>
            </a:extLst>
          </p:cNvPr>
          <p:cNvSpPr txBox="1"/>
          <p:nvPr/>
        </p:nvSpPr>
        <p:spPr>
          <a:xfrm>
            <a:off x="78916" y="256731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2EC9A27-767C-7645-86D1-E2F637F47543}"/>
              </a:ext>
            </a:extLst>
          </p:cNvPr>
          <p:cNvSpPr txBox="1"/>
          <p:nvPr/>
        </p:nvSpPr>
        <p:spPr>
          <a:xfrm>
            <a:off x="4392386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7AAB6F5-DC8C-F648-87DA-7744B31B65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388" y="452438"/>
            <a:ext cx="59309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439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A12584F-771A-8B40-848C-277538D0B4BE}"/>
              </a:ext>
            </a:extLst>
          </p:cNvPr>
          <p:cNvSpPr txBox="1"/>
          <p:nvPr/>
        </p:nvSpPr>
        <p:spPr>
          <a:xfrm>
            <a:off x="118999" y="218725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7CECDE-76E1-0A4A-9B6F-8CFC1037AA18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D0C3C2B-7AAF-F643-A3FB-5867AB9B1D88}"/>
              </a:ext>
            </a:extLst>
          </p:cNvPr>
          <p:cNvGrpSpPr/>
          <p:nvPr/>
        </p:nvGrpSpPr>
        <p:grpSpPr>
          <a:xfrm>
            <a:off x="447935" y="372613"/>
            <a:ext cx="2329775" cy="2559551"/>
            <a:chOff x="447935" y="372613"/>
            <a:chExt cx="2329775" cy="255955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F58927F-3AD8-E846-B89B-1D00AB78BE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28709"/>
            <a:stretch/>
          </p:blipFill>
          <p:spPr>
            <a:xfrm>
              <a:off x="447935" y="372613"/>
              <a:ext cx="1903379" cy="255955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30D7EA7-6DD4-CE48-A7BB-A10B3A4CB2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8059" t="12386" b="65283"/>
            <a:stretch/>
          </p:blipFill>
          <p:spPr>
            <a:xfrm>
              <a:off x="1924918" y="526502"/>
              <a:ext cx="852792" cy="5715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74251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11208AF2-6905-F5A4-C872-3A2A3439FEBC}"/>
              </a:ext>
            </a:extLst>
          </p:cNvPr>
          <p:cNvSpPr txBox="1"/>
          <p:nvPr/>
        </p:nvSpPr>
        <p:spPr>
          <a:xfrm>
            <a:off x="116624" y="92665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05B0E9A-FC38-416C-27AD-35F834B0A239}"/>
              </a:ext>
            </a:extLst>
          </p:cNvPr>
          <p:cNvSpPr txBox="1"/>
          <p:nvPr/>
        </p:nvSpPr>
        <p:spPr>
          <a:xfrm>
            <a:off x="112616" y="2219175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815397B-5F25-877B-D6EC-922106F9DE6B}"/>
              </a:ext>
            </a:extLst>
          </p:cNvPr>
          <p:cNvSpPr txBox="1"/>
          <p:nvPr/>
        </p:nvSpPr>
        <p:spPr>
          <a:xfrm>
            <a:off x="123036" y="4428337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4E5EE34-2E44-8445-8D3F-83D7891172AB}"/>
              </a:ext>
            </a:extLst>
          </p:cNvPr>
          <p:cNvGrpSpPr>
            <a:grpSpLocks noChangeAspect="1"/>
          </p:cNvGrpSpPr>
          <p:nvPr/>
        </p:nvGrpSpPr>
        <p:grpSpPr>
          <a:xfrm>
            <a:off x="409103" y="2526952"/>
            <a:ext cx="6044743" cy="1836000"/>
            <a:chOff x="427495" y="4877727"/>
            <a:chExt cx="5152876" cy="1565108"/>
          </a:xfrm>
        </p:grpSpPr>
        <p:pic>
          <p:nvPicPr>
            <p:cNvPr id="13" name="Picture 12" descr="A graph of a cell number&#10;&#10;Description automatically generated with medium confidence">
              <a:extLst>
                <a:ext uri="{FF2B5EF4-FFF2-40B4-BE49-F238E27FC236}">
                  <a16:creationId xmlns:a16="http://schemas.microsoft.com/office/drawing/2014/main" id="{D86DC00A-BD78-8C0D-2A8B-2A82191031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39770" y="4877727"/>
              <a:ext cx="1440601" cy="1440601"/>
            </a:xfrm>
            <a:prstGeom prst="rect">
              <a:avLst/>
            </a:prstGeom>
          </p:spPr>
        </p:pic>
        <p:pic>
          <p:nvPicPr>
            <p:cNvPr id="15" name="Picture 14" descr="A graph with numbers and lines&#10;&#10;Description automatically generated">
              <a:extLst>
                <a:ext uri="{FF2B5EF4-FFF2-40B4-BE49-F238E27FC236}">
                  <a16:creationId xmlns:a16="http://schemas.microsoft.com/office/drawing/2014/main" id="{D9303E02-EF14-66DB-35F7-EEC4448E49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04752" y="4879717"/>
              <a:ext cx="1440601" cy="1440601"/>
            </a:xfrm>
            <a:prstGeom prst="rect">
              <a:avLst/>
            </a:prstGeom>
          </p:spPr>
        </p:pic>
        <p:pic>
          <p:nvPicPr>
            <p:cNvPr id="30" name="Picture 29" descr="A chart of different types of data&#10;&#10;Description automatically generated with medium confidence">
              <a:extLst>
                <a:ext uri="{FF2B5EF4-FFF2-40B4-BE49-F238E27FC236}">
                  <a16:creationId xmlns:a16="http://schemas.microsoft.com/office/drawing/2014/main" id="{EE948D3B-5565-DA69-B464-879D66B48B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95" y="4877728"/>
              <a:ext cx="1956107" cy="1565107"/>
            </a:xfrm>
            <a:prstGeom prst="rect">
              <a:avLst/>
            </a:prstGeom>
          </p:spPr>
        </p:pic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376B8812-88F5-A744-866D-096FA967D05D}"/>
              </a:ext>
            </a:extLst>
          </p:cNvPr>
          <p:cNvGrpSpPr>
            <a:grpSpLocks noChangeAspect="1"/>
          </p:cNvGrpSpPr>
          <p:nvPr/>
        </p:nvGrpSpPr>
        <p:grpSpPr>
          <a:xfrm>
            <a:off x="409505" y="4769584"/>
            <a:ext cx="6044740" cy="1836000"/>
            <a:chOff x="427495" y="6659246"/>
            <a:chExt cx="5152876" cy="1565109"/>
          </a:xfrm>
        </p:grpSpPr>
        <p:pic>
          <p:nvPicPr>
            <p:cNvPr id="19" name="Picture 18" descr="A graph with blue dots&#10;&#10;Description automatically generated">
              <a:extLst>
                <a:ext uri="{FF2B5EF4-FFF2-40B4-BE49-F238E27FC236}">
                  <a16:creationId xmlns:a16="http://schemas.microsoft.com/office/drawing/2014/main" id="{D273F2D9-E26C-2C38-3DB8-D48A59DE9C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39770" y="6659247"/>
              <a:ext cx="1440601" cy="1440601"/>
            </a:xfrm>
            <a:prstGeom prst="rect">
              <a:avLst/>
            </a:prstGeom>
          </p:spPr>
        </p:pic>
        <p:pic>
          <p:nvPicPr>
            <p:cNvPr id="21" name="Picture 20" descr="A graph with blue dots&#10;&#10;Description automatically generated">
              <a:extLst>
                <a:ext uri="{FF2B5EF4-FFF2-40B4-BE49-F238E27FC236}">
                  <a16:creationId xmlns:a16="http://schemas.microsoft.com/office/drawing/2014/main" id="{AE921AF7-CAFD-4E0C-77BB-4238BEF4291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04752" y="6659246"/>
              <a:ext cx="1440601" cy="1440601"/>
            </a:xfrm>
            <a:prstGeom prst="rect">
              <a:avLst/>
            </a:prstGeom>
          </p:spPr>
        </p:pic>
        <p:pic>
          <p:nvPicPr>
            <p:cNvPr id="32" name="Picture 31" descr="A graph with green and black lines&#10;&#10;Description automatically generated">
              <a:extLst>
                <a:ext uri="{FF2B5EF4-FFF2-40B4-BE49-F238E27FC236}">
                  <a16:creationId xmlns:a16="http://schemas.microsoft.com/office/drawing/2014/main" id="{1F7BA19F-BDBF-292C-E9AF-299E1E9519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95" y="6664179"/>
              <a:ext cx="1949944" cy="1560176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8A326A94-97AB-6743-994D-4B180A6E9776}"/>
              </a:ext>
            </a:extLst>
          </p:cNvPr>
          <p:cNvGrpSpPr>
            <a:grpSpLocks noChangeAspect="1"/>
          </p:cNvGrpSpPr>
          <p:nvPr/>
        </p:nvGrpSpPr>
        <p:grpSpPr>
          <a:xfrm>
            <a:off x="404527" y="338191"/>
            <a:ext cx="6036564" cy="1836000"/>
            <a:chOff x="420026" y="362038"/>
            <a:chExt cx="5160345" cy="1569501"/>
          </a:xfrm>
        </p:grpSpPr>
        <p:pic>
          <p:nvPicPr>
            <p:cNvPr id="26" name="Picture 25" descr="A graph with numbers and dots&#10;&#10;Description automatically generated">
              <a:extLst>
                <a:ext uri="{FF2B5EF4-FFF2-40B4-BE49-F238E27FC236}">
                  <a16:creationId xmlns:a16="http://schemas.microsoft.com/office/drawing/2014/main" id="{235091DC-A788-50BC-0F5E-CA514AE4F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39770" y="362038"/>
              <a:ext cx="1440601" cy="1440601"/>
            </a:xfrm>
            <a:prstGeom prst="rect">
              <a:avLst/>
            </a:prstGeom>
          </p:spPr>
        </p:pic>
        <p:pic>
          <p:nvPicPr>
            <p:cNvPr id="28" name="Picture 27" descr="A graph with numbers and lines&#10;&#10;Description automatically generated">
              <a:extLst>
                <a:ext uri="{FF2B5EF4-FFF2-40B4-BE49-F238E27FC236}">
                  <a16:creationId xmlns:a16="http://schemas.microsoft.com/office/drawing/2014/main" id="{BD35E8A7-6420-52C9-AFC9-76FB4B9DE39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504751" y="362038"/>
              <a:ext cx="1440601" cy="1440601"/>
            </a:xfrm>
            <a:prstGeom prst="rect">
              <a:avLst/>
            </a:prstGeom>
          </p:spPr>
        </p:pic>
        <p:pic>
          <p:nvPicPr>
            <p:cNvPr id="34" name="Picture 33" descr="A graph of different colored lines&#10;&#10;Description automatically generated with medium confidence">
              <a:extLst>
                <a:ext uri="{FF2B5EF4-FFF2-40B4-BE49-F238E27FC236}">
                  <a16:creationId xmlns:a16="http://schemas.microsoft.com/office/drawing/2014/main" id="{42CFFDB0-4E51-C889-DDB2-F5D938D32D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026" y="365387"/>
              <a:ext cx="1957413" cy="1566152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BA5B183-64E2-3143-9CF3-D02E7BAF5D83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C9640A9-2165-204C-A684-9312215D859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4527" y="6975204"/>
            <a:ext cx="6302829" cy="1708931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BB0A794-3982-C24B-842D-18F04D78B168}"/>
                  </a:ext>
                </a:extLst>
              </p:cNvPr>
              <p:cNvSpPr txBox="1"/>
              <p:nvPr/>
            </p:nvSpPr>
            <p:spPr>
              <a:xfrm>
                <a:off x="389029" y="8637639"/>
                <a:ext cx="5670434" cy="1110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Screening Statistics:</a:t>
                </a:r>
              </a:p>
              <a:p>
                <a:r>
                  <a:rPr lang="en-GB" sz="1000" dirty="0"/>
                  <a:t>Mean: mean of positive and negative control wells</a:t>
                </a:r>
              </a:p>
              <a:p>
                <a:r>
                  <a:rPr lang="en-GB" sz="1000" dirty="0"/>
                  <a:t>SD: standard deviation of positive and negative control wells</a:t>
                </a:r>
              </a:p>
              <a:p>
                <a:r>
                  <a:rPr lang="en-GB" sz="1000" dirty="0"/>
                  <a:t>CV: coefficient of variation (SD/Mean)x100</a:t>
                </a:r>
              </a:p>
              <a:p>
                <a:r>
                  <a:rPr lang="en-GB" sz="1000" dirty="0"/>
                  <a:t>SB: </a:t>
                </a:r>
                <a:r>
                  <a:rPr lang="en-GB" sz="1000" dirty="0" err="1"/>
                  <a:t>Signal:Background</a:t>
                </a:r>
                <a:r>
                  <a:rPr lang="en-GB" sz="1000" dirty="0"/>
                  <a:t> (fold-change over DMSO control)</a:t>
                </a:r>
              </a:p>
              <a:p>
                <a:r>
                  <a:rPr lang="en-GB" sz="1000" dirty="0"/>
                  <a:t>Z’: screening metric </a:t>
                </a:r>
                <a14:m>
                  <m:oMath xmlns:m="http://schemas.openxmlformats.org/officeDocument/2006/math">
                    <m:r>
                      <a:rPr lang="en-GB" sz="1000" b="0" i="1" smtClean="0">
                        <a:latin typeface="Cambria Math" panose="02040503050406030204" pitchFamily="18" charset="0"/>
                      </a:rPr>
                      <m:t>1−(</m:t>
                    </m:r>
                    <m:f>
                      <m:fPr>
                        <m:ctrlPr>
                          <a:rPr lang="en-GB" sz="1000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3∗(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𝑀𝐴𝐷</m:t>
                        </m:r>
                        <m:d>
                          <m:dPr>
                            <m:ctrlP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+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𝑣𝑒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 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𝑐𝑡𝑟𝑙</m:t>
                            </m:r>
                          </m:e>
                        </m:d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+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𝑀𝐴𝐷</m:t>
                        </m:r>
                        <m:d>
                          <m:dPr>
                            <m:ctrlP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𝑣𝑒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 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𝑐𝑡𝑟𝑙</m:t>
                            </m:r>
                          </m:e>
                        </m:d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)</m:t>
                        </m:r>
                      </m:num>
                      <m:den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𝑀𝑒𝑑𝑖𝑎𝑛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d>
                          <m:dPr>
                            <m:ctrlP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+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𝑣𝑒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 </m:t>
                            </m:r>
                            <m:r>
                              <a:rPr lang="en-GB" sz="1000" b="0" i="1" smtClean="0">
                                <a:latin typeface="Cambria Math" panose="02040503050406030204" pitchFamily="18" charset="0"/>
                              </a:rPr>
                              <m:t>𝑐𝑡𝑟𝑙</m:t>
                            </m:r>
                          </m:e>
                        </m:d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−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𝑀𝑒𝑑𝑖𝑎𝑛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 (−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𝑣𝑒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𝑐𝑡𝑟𝑙</m:t>
                        </m:r>
                        <m:r>
                          <a:rPr lang="en-GB" sz="1000" b="0" i="1" smtClean="0">
                            <a:latin typeface="Cambria Math" panose="02040503050406030204" pitchFamily="18" charset="0"/>
                          </a:rPr>
                          <m:t>)</m:t>
                        </m:r>
                      </m:den>
                    </m:f>
                    <m:r>
                      <a:rPr lang="en-GB" sz="1000" b="0" i="1" smtClean="0">
                        <a:latin typeface="Cambria Math" panose="02040503050406030204" pitchFamily="18" charset="0"/>
                      </a:rPr>
                      <m:t>)</m:t>
                    </m:r>
                  </m:oMath>
                </a14:m>
                <a:endParaRPr lang="en-GB" sz="1000" dirty="0"/>
              </a:p>
            </p:txBody>
          </p:sp>
        </mc:Choice>
        <mc:Fallback xmlns=""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BB0A794-3982-C24B-842D-18F04D78B16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89029" y="8637639"/>
                <a:ext cx="5670434" cy="1110945"/>
              </a:xfrm>
              <a:prstGeom prst="rect">
                <a:avLst/>
              </a:prstGeom>
              <a:blipFill>
                <a:blip r:embed="rId1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7" name="TextBox 26">
            <a:extLst>
              <a:ext uri="{FF2B5EF4-FFF2-40B4-BE49-F238E27FC236}">
                <a16:creationId xmlns:a16="http://schemas.microsoft.com/office/drawing/2014/main" id="{1712F06E-DE07-5249-8365-6279159DFDF8}"/>
              </a:ext>
            </a:extLst>
          </p:cNvPr>
          <p:cNvSpPr txBox="1"/>
          <p:nvPr/>
        </p:nvSpPr>
        <p:spPr>
          <a:xfrm>
            <a:off x="112616" y="6574501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39540229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patient&#10;&#10;Description automatically generated with medium confidence">
            <a:extLst>
              <a:ext uri="{FF2B5EF4-FFF2-40B4-BE49-F238E27FC236}">
                <a16:creationId xmlns:a16="http://schemas.microsoft.com/office/drawing/2014/main" id="{5FEB43DA-E87A-FB50-08E9-AFF8EDB3A354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074" y="457543"/>
            <a:ext cx="2274084" cy="18549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335139-4387-1EAC-DCAC-FB7032DC91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1764" y="469810"/>
            <a:ext cx="1973984" cy="1579410"/>
          </a:xfrm>
          <a:prstGeom prst="rect">
            <a:avLst/>
          </a:prstGeom>
        </p:spPr>
      </p:pic>
      <p:pic>
        <p:nvPicPr>
          <p:cNvPr id="11" name="Picture 10" descr="A graph with a dotted line and blue dots&#10;&#10;Description automatically generated">
            <a:extLst>
              <a:ext uri="{FF2B5EF4-FFF2-40B4-BE49-F238E27FC236}">
                <a16:creationId xmlns:a16="http://schemas.microsoft.com/office/drawing/2014/main" id="{141A9FA1-1732-2B1F-5C3E-0A61EFCD25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7471" y="5334243"/>
            <a:ext cx="1973985" cy="1579411"/>
          </a:xfrm>
          <a:prstGeom prst="rect">
            <a:avLst/>
          </a:prstGeom>
        </p:spPr>
      </p:pic>
      <p:pic>
        <p:nvPicPr>
          <p:cNvPr id="15" name="Picture 14" descr="A graph with blue dots&#10;&#10;Description automatically generated">
            <a:extLst>
              <a:ext uri="{FF2B5EF4-FFF2-40B4-BE49-F238E27FC236}">
                <a16:creationId xmlns:a16="http://schemas.microsoft.com/office/drawing/2014/main" id="{47D4A7F9-767D-41F4-9513-CA39B44C95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6112" y="5334245"/>
            <a:ext cx="1973984" cy="157941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A722EFB4-B9AD-A7BA-5D58-490DEDAC5CF6}"/>
              </a:ext>
            </a:extLst>
          </p:cNvPr>
          <p:cNvSpPr txBox="1"/>
          <p:nvPr/>
        </p:nvSpPr>
        <p:spPr>
          <a:xfrm>
            <a:off x="138536" y="267961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e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AAE6021-77CB-2746-EBEE-CD27583645A0}"/>
              </a:ext>
            </a:extLst>
          </p:cNvPr>
          <p:cNvSpPr txBox="1"/>
          <p:nvPr/>
        </p:nvSpPr>
        <p:spPr>
          <a:xfrm>
            <a:off x="2605696" y="267961"/>
            <a:ext cx="2995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f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ECC2793-9FC4-5F11-FEA9-9AF66CDD8237}"/>
              </a:ext>
            </a:extLst>
          </p:cNvPr>
          <p:cNvSpPr txBox="1"/>
          <p:nvPr/>
        </p:nvSpPr>
        <p:spPr>
          <a:xfrm>
            <a:off x="174215" y="5180355"/>
            <a:ext cx="33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h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E885019-00CB-A93C-2DBA-35BF72205128}"/>
              </a:ext>
            </a:extLst>
          </p:cNvPr>
          <p:cNvSpPr txBox="1"/>
          <p:nvPr/>
        </p:nvSpPr>
        <p:spPr>
          <a:xfrm>
            <a:off x="174215" y="2518650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g)</a:t>
            </a:r>
          </a:p>
        </p:txBody>
      </p:sp>
      <p:pic>
        <p:nvPicPr>
          <p:cNvPr id="27" name="Picture 26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A0BBB671-39C5-9469-121A-499B092281F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0479" y="2631412"/>
            <a:ext cx="2120641" cy="2120641"/>
          </a:xfrm>
          <a:prstGeom prst="rect">
            <a:avLst/>
          </a:prstGeom>
        </p:spPr>
      </p:pic>
      <p:pic>
        <p:nvPicPr>
          <p:cNvPr id="29" name="Picture 28" descr="A graph with numbers and dots&#10;&#10;Description automatically generated">
            <a:extLst>
              <a:ext uri="{FF2B5EF4-FFF2-40B4-BE49-F238E27FC236}">
                <a16:creationId xmlns:a16="http://schemas.microsoft.com/office/drawing/2014/main" id="{233F6FE2-6F76-0C30-EA73-D0D55360FA0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7471" y="2631412"/>
            <a:ext cx="2120640" cy="212064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F46AAA6-B1F5-844E-B206-0E20BD344442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42435817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979B7DE-1AFD-354F-A03C-6445867C6929}"/>
              </a:ext>
            </a:extLst>
          </p:cNvPr>
          <p:cNvSpPr txBox="1"/>
          <p:nvPr/>
        </p:nvSpPr>
        <p:spPr>
          <a:xfrm>
            <a:off x="220625" y="202993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i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C37C2D0-809B-B64C-936B-8BF0700D605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65"/>
          <a:stretch/>
        </p:blipFill>
        <p:spPr>
          <a:xfrm>
            <a:off x="555655" y="305712"/>
            <a:ext cx="5920911" cy="792388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1193B05-B68F-534C-886F-138C32262203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806961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CE9242D-A10E-7B4B-A77F-5CABE0DC84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863" y="279529"/>
            <a:ext cx="6332537" cy="91680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93162EE-1FC9-CD4F-88D1-663804CC5CCA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EC1982-FCFF-504D-B836-086BE285887E}"/>
              </a:ext>
            </a:extLst>
          </p:cNvPr>
          <p:cNvSpPr txBox="1"/>
          <p:nvPr/>
        </p:nvSpPr>
        <p:spPr>
          <a:xfrm>
            <a:off x="119126" y="9060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j)</a:t>
            </a:r>
          </a:p>
        </p:txBody>
      </p:sp>
    </p:spTree>
    <p:extLst>
      <p:ext uri="{BB962C8B-B14F-4D97-AF65-F5344CB8AC3E}">
        <p14:creationId xmlns:p14="http://schemas.microsoft.com/office/powerpoint/2010/main" val="32695339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E39375A-E7DD-B443-B3D4-0CE039FFA7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160" y="290830"/>
            <a:ext cx="6376379" cy="9172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AE1EE30-E4A7-694E-BAAB-817FC6930DB8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F7B2B35-8FF0-A641-B579-EB408B347E8C}"/>
              </a:ext>
            </a:extLst>
          </p:cNvPr>
          <p:cNvSpPr txBox="1"/>
          <p:nvPr/>
        </p:nvSpPr>
        <p:spPr>
          <a:xfrm>
            <a:off x="119126" y="9060"/>
            <a:ext cx="809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i="1" dirty="0"/>
              <a:t>j) (cont.)</a:t>
            </a:r>
          </a:p>
        </p:txBody>
      </p:sp>
    </p:spTree>
    <p:extLst>
      <p:ext uri="{BB962C8B-B14F-4D97-AF65-F5344CB8AC3E}">
        <p14:creationId xmlns:p14="http://schemas.microsoft.com/office/powerpoint/2010/main" val="11825681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ECA57B7-BD69-6A42-84E1-090346145B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304" y="376238"/>
            <a:ext cx="6325647" cy="33575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07CF73C-93E3-7147-B4F3-66FC4BBA9B1A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EA784B-D677-8748-9B42-61CACB3BAFB4}"/>
              </a:ext>
            </a:extLst>
          </p:cNvPr>
          <p:cNvSpPr txBox="1"/>
          <p:nvPr/>
        </p:nvSpPr>
        <p:spPr>
          <a:xfrm>
            <a:off x="119126" y="9060"/>
            <a:ext cx="809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i="1" dirty="0"/>
              <a:t>j) (cont.)</a:t>
            </a:r>
          </a:p>
        </p:txBody>
      </p:sp>
    </p:spTree>
    <p:extLst>
      <p:ext uri="{BB962C8B-B14F-4D97-AF65-F5344CB8AC3E}">
        <p14:creationId xmlns:p14="http://schemas.microsoft.com/office/powerpoint/2010/main" val="2186589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3712EDC-E96D-A84E-8D88-B386EFC33517}"/>
              </a:ext>
            </a:extLst>
          </p:cNvPr>
          <p:cNvSpPr txBox="1"/>
          <p:nvPr/>
        </p:nvSpPr>
        <p:spPr>
          <a:xfrm>
            <a:off x="73220" y="104671"/>
            <a:ext cx="327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k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8493215-E6BE-DD41-997F-025BDAB0FE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687" y="328246"/>
            <a:ext cx="6467411" cy="34951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0C2B2CA-8CBD-F341-9CD5-0188C57C1F1E}"/>
              </a:ext>
            </a:extLst>
          </p:cNvPr>
          <p:cNvSpPr txBox="1"/>
          <p:nvPr/>
        </p:nvSpPr>
        <p:spPr>
          <a:xfrm>
            <a:off x="4319962" y="947057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61063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18</TotalTime>
  <Words>184</Words>
  <Application>Microsoft Macintosh PowerPoint</Application>
  <PresentationFormat>A4 Paper (210x297 mm)</PresentationFormat>
  <Paragraphs>81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ano de la Vega (Staff)</dc:creator>
  <cp:lastModifiedBy>Laureano de la Vega (Staff)</cp:lastModifiedBy>
  <cp:revision>178</cp:revision>
  <dcterms:created xsi:type="dcterms:W3CDTF">2024-07-17T15:56:42Z</dcterms:created>
  <dcterms:modified xsi:type="dcterms:W3CDTF">2026-03-08T11:38:56Z</dcterms:modified>
</cp:coreProperties>
</file>